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4" r:id="rId3"/>
    <p:sldId id="263" r:id="rId4"/>
    <p:sldId id="267" r:id="rId5"/>
    <p:sldId id="268" r:id="rId6"/>
    <p:sldId id="269" r:id="rId7"/>
    <p:sldId id="270" r:id="rId8"/>
    <p:sldId id="264" r:id="rId9"/>
    <p:sldId id="271" r:id="rId10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5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19623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81010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3388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15963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8721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5099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6609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61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1379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5805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786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67DE0-95AB-40CE-AAC6-9D57906DCAC1}" type="datetimeFigureOut">
              <a:rPr lang="en-AU" smtClean="0"/>
              <a:t>16/06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BF446-9507-4C44-8E30-80295EE4F06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0823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gif"/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2" t="44486" r="27745" b="8242"/>
          <a:stretch/>
        </p:blipFill>
        <p:spPr>
          <a:xfrm>
            <a:off x="8332039" y="942717"/>
            <a:ext cx="3791154" cy="20114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1" t="44485" r="27952" b="9697"/>
          <a:stretch/>
        </p:blipFill>
        <p:spPr>
          <a:xfrm>
            <a:off x="6827089" y="4311186"/>
            <a:ext cx="3791154" cy="20240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" t="45697" r="28027" b="7532"/>
          <a:stretch/>
        </p:blipFill>
        <p:spPr>
          <a:xfrm>
            <a:off x="181471" y="942717"/>
            <a:ext cx="3768828" cy="20114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" t="44848" r="27738" b="8884"/>
          <a:stretch/>
        </p:blipFill>
        <p:spPr>
          <a:xfrm>
            <a:off x="1187829" y="4311186"/>
            <a:ext cx="3791426" cy="20240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2" t="45212" r="27981" b="8485"/>
          <a:stretch/>
        </p:blipFill>
        <p:spPr>
          <a:xfrm>
            <a:off x="4245592" y="942717"/>
            <a:ext cx="3791154" cy="20114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Right Arrow 6"/>
          <p:cNvSpPr/>
          <p:nvPr/>
        </p:nvSpPr>
        <p:spPr>
          <a:xfrm>
            <a:off x="3950299" y="1847850"/>
            <a:ext cx="295293" cy="20002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Right Arrow 7"/>
          <p:cNvSpPr/>
          <p:nvPr/>
        </p:nvSpPr>
        <p:spPr>
          <a:xfrm>
            <a:off x="8026999" y="1857375"/>
            <a:ext cx="295293" cy="20002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Right Arrow 8"/>
          <p:cNvSpPr/>
          <p:nvPr/>
        </p:nvSpPr>
        <p:spPr>
          <a:xfrm rot="5400000" flipV="1">
            <a:off x="8671687" y="3489910"/>
            <a:ext cx="1106729" cy="2002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Right Arrow 9"/>
          <p:cNvSpPr/>
          <p:nvPr/>
        </p:nvSpPr>
        <p:spPr>
          <a:xfrm rot="10800000" flipV="1">
            <a:off x="5395087" y="5290135"/>
            <a:ext cx="1106729" cy="2002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" name="TextBox 10"/>
          <p:cNvSpPr txBox="1"/>
          <p:nvPr/>
        </p:nvSpPr>
        <p:spPr>
          <a:xfrm>
            <a:off x="1524000" y="3036646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ime 0 min</a:t>
            </a:r>
            <a:endParaRPr lang="en-AU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5648325" y="3036646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ime 30 min</a:t>
            </a:r>
            <a:endParaRPr lang="en-AU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9563100" y="3036646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ime 120 min</a:t>
            </a:r>
            <a:endParaRPr lang="en-AU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8191500" y="6397162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ime 360 min</a:t>
            </a:r>
            <a:endParaRPr lang="en-AU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2324100" y="6406687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ime 1440 min</a:t>
            </a:r>
            <a:endParaRPr lang="en-AU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5509054" y="6304005"/>
            <a:ext cx="104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. </a:t>
            </a:r>
            <a:r>
              <a:rPr lang="en-AU" dirty="0"/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20961032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1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5" r="3578"/>
          <a:stretch/>
        </p:blipFill>
        <p:spPr bwMode="auto">
          <a:xfrm>
            <a:off x="108065" y="96203"/>
            <a:ext cx="3674226" cy="150998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1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3" r="3817"/>
          <a:stretch/>
        </p:blipFill>
        <p:spPr bwMode="auto">
          <a:xfrm>
            <a:off x="4218700" y="117098"/>
            <a:ext cx="3599411" cy="148212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1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1" t="5318" r="3561"/>
          <a:stretch/>
        </p:blipFill>
        <p:spPr bwMode="auto">
          <a:xfrm>
            <a:off x="8254520" y="110134"/>
            <a:ext cx="3599411" cy="149605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10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5" t="4595" r="3858"/>
          <a:stretch/>
        </p:blipFill>
        <p:spPr bwMode="auto">
          <a:xfrm>
            <a:off x="108066" y="2307386"/>
            <a:ext cx="3674225" cy="150998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1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5" t="3486" r="4695"/>
          <a:stretch/>
        </p:blipFill>
        <p:spPr bwMode="auto">
          <a:xfrm>
            <a:off x="4189608" y="2307386"/>
            <a:ext cx="3674226" cy="150931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5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6" t="3116" r="4416"/>
          <a:stretch/>
        </p:blipFill>
        <p:spPr bwMode="auto">
          <a:xfrm>
            <a:off x="8229588" y="2307386"/>
            <a:ext cx="3674226" cy="150931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 flipH="1" flipV="1">
            <a:off x="1504604" y="548640"/>
            <a:ext cx="357448" cy="33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1817010" y="443391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DR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 flipH="1" flipV="1">
            <a:off x="5563976" y="701040"/>
            <a:ext cx="357448" cy="33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876382" y="595791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DR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 flipH="1" flipV="1">
            <a:off x="9615036" y="703810"/>
            <a:ext cx="357448" cy="33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9927442" y="598561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DR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 flipH="1" flipV="1">
            <a:off x="9659367" y="2984266"/>
            <a:ext cx="357448" cy="33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9971773" y="2879017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DR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 flipH="1" flipV="1">
            <a:off x="5605535" y="3003662"/>
            <a:ext cx="357448" cy="33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917941" y="2898413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DR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 flipV="1">
            <a:off x="1485202" y="2748737"/>
            <a:ext cx="357448" cy="33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797608" y="2643488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DR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55613" y="1689318"/>
            <a:ext cx="306190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764846" y="1666101"/>
            <a:ext cx="306190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0048664" y="1668874"/>
            <a:ext cx="306190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636884" y="3922623"/>
            <a:ext cx="306190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784259" y="3921946"/>
            <a:ext cx="306190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0034826" y="3924716"/>
            <a:ext cx="306190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509054" y="6304005"/>
            <a:ext cx="104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. S2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435440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09054" y="6304005"/>
            <a:ext cx="104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Table S1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9477493"/>
              </p:ext>
            </p:extLst>
          </p:nvPr>
        </p:nvGraphicFramePr>
        <p:xfrm>
          <a:off x="3172142" y="3218466"/>
          <a:ext cx="5847715" cy="156565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88722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6047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6967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5303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 charact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ellent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≤1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–1.1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–30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–1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–1.18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–3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–2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–1.2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–4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ssable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–25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–1.3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–4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r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–31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–1.4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–5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 poor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–37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–1.59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–6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, very poo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38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1.6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6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47083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7303837"/>
              </p:ext>
            </p:extLst>
          </p:nvPr>
        </p:nvGraphicFramePr>
        <p:xfrm>
          <a:off x="2068320" y="223837"/>
          <a:ext cx="9297347" cy="2071688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8184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3848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43062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52309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hematical models to determine the release kinetic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16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quation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16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ord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ln Q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K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 rowSpan="5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amount of drug dissolved in time t,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initial amount of drug in the solution,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: time,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∞: 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of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g dissolved in time ∞.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 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K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K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K</a:t>
                      </a:r>
                      <a:r>
                        <a:rPr lang="en-AU" sz="12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re the rate constants for first order, zero order, Hixson–Crowell, Higuchi-matrix and Korsmeyer–Peppas resepctively.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16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ro order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Q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K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16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xson–Crowell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3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− Q</a:t>
                      </a:r>
                      <a:r>
                        <a:rPr lang="en-AU" sz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3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= 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AU" sz="1200" baseline="-25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16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uchi-matrix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K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 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9348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rsmeyer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pas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r>
                        <a:rPr lang="en-AU" sz="1200" baseline="-25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Q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∞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K</a:t>
                      </a:r>
                      <a:r>
                        <a:rPr lang="en-AU" sz="12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 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AU" sz="1200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509054" y="6304005"/>
            <a:ext cx="1105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Table </a:t>
            </a:r>
            <a:r>
              <a:rPr lang="en-AU" dirty="0" smtClean="0"/>
              <a:t>S2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7536582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9169417"/>
              </p:ext>
            </p:extLst>
          </p:nvPr>
        </p:nvGraphicFramePr>
        <p:xfrm>
          <a:off x="1175995" y="1825624"/>
          <a:ext cx="9297347" cy="172402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8184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3848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43062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52309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ease profiles comparison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8068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similarity factor (f1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: sampling number,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j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j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 percent dissolved of the reference and test products at each time point j,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047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milarity factor (f2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4441" marR="3444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pic>
        <p:nvPicPr>
          <p:cNvPr id="3" name="Picture 2" descr="Full-size image (&lt;1 K)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0090" y="2034708"/>
            <a:ext cx="1681142" cy="3990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Full-size image (&lt;1 K)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6660" y="2665938"/>
            <a:ext cx="3948073" cy="6042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5201232" y="6382950"/>
            <a:ext cx="9553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/>
              <a:t>Table </a:t>
            </a:r>
            <a:r>
              <a:rPr lang="en-AU" dirty="0" smtClean="0"/>
              <a:t>S3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8192088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1298685"/>
              </p:ext>
            </p:extLst>
          </p:nvPr>
        </p:nvGraphicFramePr>
        <p:xfrm>
          <a:off x="164756" y="1581666"/>
          <a:ext cx="11829536" cy="324570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59755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59755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7588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58524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58524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6873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16696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452353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208504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ulation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um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h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h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h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70469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 size</a:t>
                      </a:r>
                      <a:r>
                        <a:rPr lang="en-AU" sz="12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m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 size (nm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 size (nm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13084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NLNS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t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5 ± 3.5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0.01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51 ± 2.3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0.01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82</a:t>
                      </a:r>
                      <a:r>
                        <a:rPr lang="en-AU" sz="1200" kern="12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4.6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0.01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13084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F (pH 1.2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48 ± 2.1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 0.01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9 ± 3.6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 0.01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68 ± 3.1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± 0.01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13084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 (pH 6.8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28</a:t>
                      </a:r>
                      <a:r>
                        <a:rPr lang="en-AU" sz="1200" kern="12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8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 0.01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45</a:t>
                      </a:r>
                      <a:r>
                        <a:rPr lang="en-AU" sz="1200" kern="12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2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± 0.01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21</a:t>
                      </a:r>
                      <a:r>
                        <a:rPr lang="en-AU" sz="1200" kern="12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9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± 0.01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0916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-NLNS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t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25 ± 4.5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56 ± 2.9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34 ± 3.1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09160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F (pH 1.2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58 ± 3.1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51 ± 2.4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94 ± 4.5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409160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 (pH 6.8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73 ± 2.9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45 ± 3.5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02 ± 2.4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509054" y="6304005"/>
            <a:ext cx="104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Table </a:t>
            </a:r>
            <a:r>
              <a:rPr lang="en-AU" dirty="0" smtClean="0"/>
              <a:t>S4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924041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6804762"/>
              </p:ext>
            </p:extLst>
          </p:nvPr>
        </p:nvGraphicFramePr>
        <p:xfrm>
          <a:off x="3258171" y="2541873"/>
          <a:ext cx="6017634" cy="1684137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19219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9422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1175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8498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33448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7217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 (L-NLNS: 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rosil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® 200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 charact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405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0.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83 ± 2.4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5 ± 0.0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68 ± 4.5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, very poor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405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0.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57 ± 1.1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5 ± 0.0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2 ± 3.1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405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0.8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8 ± 1.9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 ± 0.0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92 ± 3.2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405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7 ± 1.10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 ± 0.0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19 ± 2.8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ellent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509054" y="6304005"/>
            <a:ext cx="104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Table </a:t>
            </a:r>
            <a:r>
              <a:rPr lang="en-AU" dirty="0" smtClean="0"/>
              <a:t>S5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275637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09054" y="6304005"/>
            <a:ext cx="1105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Table </a:t>
            </a:r>
            <a:r>
              <a:rPr lang="en-AU" dirty="0" smtClean="0"/>
              <a:t>S6</a:t>
            </a:r>
            <a:endParaRPr lang="en-AU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5496730"/>
              </p:ext>
            </p:extLst>
          </p:nvPr>
        </p:nvGraphicFramePr>
        <p:xfrm>
          <a:off x="2480807" y="2434919"/>
          <a:ext cx="9111719" cy="2145399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2263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3619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1168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41168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39698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03919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293341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78486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h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h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h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35456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 size (nm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 size (nm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 size (nm)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5355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52 ± 4.5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78 ± 3.2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16 ± 4.8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5355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84 ± 2.52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10 ± 3.58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61 ± 3.1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5355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14 ± 1.9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58 ± 2.5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81 ± 2.9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5355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63 ± 2.8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20 ± 4.8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16 ± 4.80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 ±0.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9531" marR="49531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00525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09054" y="6304005"/>
            <a:ext cx="1105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/>
              <a:t>Table </a:t>
            </a:r>
            <a:r>
              <a:rPr lang="en-AU" smtClean="0"/>
              <a:t>S7</a:t>
            </a:r>
            <a:endParaRPr lang="en-AU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5938481"/>
              </p:ext>
            </p:extLst>
          </p:nvPr>
        </p:nvGraphicFramePr>
        <p:xfrm>
          <a:off x="1790174" y="2726724"/>
          <a:ext cx="8746020" cy="1612829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6482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8611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6001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3768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13768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37984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37984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39541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ulation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um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ord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ro order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xson–Crowell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uchi-matrix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rsmeyer</a:t>
                      </a: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AU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pas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38877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R suspension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F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0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8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2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3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7771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9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9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8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4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5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77710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NLN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F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02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7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4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7771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76</a:t>
                      </a:r>
                      <a:endParaRPr lang="en-AU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6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0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0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77710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-NLNS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F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78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2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66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2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3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7771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0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77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35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71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39</a:t>
                      </a:r>
                      <a:endParaRPr lang="en-AU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893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00</TotalTime>
  <Words>594</Words>
  <Application>Microsoft Office PowerPoint</Application>
  <PresentationFormat>Widescreen</PresentationFormat>
  <Paragraphs>24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South Australi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ikh, Ankitkumar Yogeshbhai - paray049</dc:creator>
  <cp:lastModifiedBy>Tanya Sinha</cp:lastModifiedBy>
  <cp:revision>70</cp:revision>
  <cp:lastPrinted>2017-05-23T04:53:54Z</cp:lastPrinted>
  <dcterms:created xsi:type="dcterms:W3CDTF">2016-09-17T04:54:22Z</dcterms:created>
  <dcterms:modified xsi:type="dcterms:W3CDTF">2017-06-16T06:59:45Z</dcterms:modified>
</cp:coreProperties>
</file>